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E9952C-C3E9-438E-9616-3F31BDEFBC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AD1E7-8209-4355-8948-EF6CC830BE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D97C0-181F-4566-9954-889D582E5D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4A509-555F-4C27-B6B4-3E78D0D03F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D592B-5047-4C93-ABDF-3DD70F828C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AA28F-8BB3-41A2-84AC-28BF7D5ED9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667FA8-3C77-4187-8C1C-571F349016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FF543-D1DF-49EA-82B6-420387D126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7193C-0A96-4519-92EF-0AD25D4785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E26B6-6289-46ED-AFEE-F4FF9FCB2E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45472-B1D2-46C1-BF6C-1159A6CD9B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00938-622D-48CF-A2FA-06450EC97A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394A8A-BE3F-42D8-90FB-59DD88FD98A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18"/>
          <p:cNvSpPr/>
          <p:nvPr/>
        </p:nvSpPr>
        <p:spPr>
          <a:xfrm>
            <a:off x="708480" y="26028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19"/>
          <p:cNvSpPr/>
          <p:nvPr/>
        </p:nvSpPr>
        <p:spPr>
          <a:xfrm>
            <a:off x="4897440" y="692280"/>
            <a:ext cx="366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22"/>
          <p:cNvSpPr/>
          <p:nvPr/>
        </p:nvSpPr>
        <p:spPr>
          <a:xfrm>
            <a:off x="171360" y="5299920"/>
            <a:ext cx="89442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1. LUC luminescence of DSB-inducible HR events by transient I-SceI expression in control,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KD-OsKu70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KD-OsLig4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rice calli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a) Bright-field image (BF) and LUC luminescence (LUC) of control (left panels)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KD-Lig4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ce calli (right panels).  LUC luminescence derived from recombination events of LU-UC recombination substrate were detected in 4-week-old transgenic rice calli with (I-SceI) or without (empty vector) induction of I-SceI expression.  A bar shows 1 cm.  (b) Graphical representation of the LUC luminescence intensity on control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KD-Ku7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KD-Lig4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ce calli.  Relative LUC luminescence levels were normalized to LUC luminescence levels of calli without induction of I-SceI expression (=100). 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rror bars represent ±SD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185"/>
          <p:cNvGrpSpPr/>
          <p:nvPr/>
        </p:nvGrpSpPr>
        <p:grpSpPr>
          <a:xfrm>
            <a:off x="4824360" y="1220760"/>
            <a:ext cx="2902680" cy="3836160"/>
            <a:chOff x="4824360" y="1220760"/>
            <a:chExt cx="2902680" cy="3836160"/>
          </a:xfrm>
        </p:grpSpPr>
        <p:sp>
          <p:nvSpPr>
            <p:cNvPr id="45" name="Rectangle 103"/>
            <p:cNvSpPr/>
            <p:nvPr/>
          </p:nvSpPr>
          <p:spPr>
            <a:xfrm>
              <a:off x="5222160" y="43876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04"/>
            <p:cNvSpPr/>
            <p:nvPr/>
          </p:nvSpPr>
          <p:spPr>
            <a:xfrm>
              <a:off x="5137200" y="3594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05"/>
            <p:cNvSpPr/>
            <p:nvPr/>
          </p:nvSpPr>
          <p:spPr>
            <a:xfrm>
              <a:off x="5052600" y="280980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06"/>
            <p:cNvSpPr/>
            <p:nvPr/>
          </p:nvSpPr>
          <p:spPr>
            <a:xfrm>
              <a:off x="5052600" y="20145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7"/>
            <p:cNvSpPr/>
            <p:nvPr/>
          </p:nvSpPr>
          <p:spPr>
            <a:xfrm>
              <a:off x="5052600" y="12207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08"/>
            <p:cNvSpPr/>
            <p:nvPr/>
          </p:nvSpPr>
          <p:spPr>
            <a:xfrm rot="16200000">
              <a:off x="4122360" y="2753280"/>
              <a:ext cx="1680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elative LUC phot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09"/>
            <p:cNvSpPr/>
            <p:nvPr/>
          </p:nvSpPr>
          <p:spPr>
            <a:xfrm>
              <a:off x="6865200" y="4460760"/>
              <a:ext cx="861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Arial"/>
                </a:rPr>
                <a:t>KD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Arial"/>
                </a:rPr>
                <a:t>Lig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10"/>
            <p:cNvSpPr/>
            <p:nvPr/>
          </p:nvSpPr>
          <p:spPr>
            <a:xfrm>
              <a:off x="6138720" y="4749840"/>
              <a:ext cx="935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U-UC9×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11"/>
            <p:cNvSpPr/>
            <p:nvPr/>
          </p:nvSpPr>
          <p:spPr>
            <a:xfrm>
              <a:off x="5328000" y="4462560"/>
              <a:ext cx="813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12"/>
            <p:cNvSpPr/>
            <p:nvPr/>
          </p:nvSpPr>
          <p:spPr>
            <a:xfrm>
              <a:off x="5443560" y="4767120"/>
              <a:ext cx="2260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13"/>
            <p:cNvSpPr/>
            <p:nvPr/>
          </p:nvSpPr>
          <p:spPr>
            <a:xfrm>
              <a:off x="5472000" y="1441440"/>
              <a:ext cx="144720" cy="144360"/>
            </a:xfrm>
            <a:prstGeom prst="rect">
              <a:avLst/>
            </a:prstGeom>
            <a:solidFill>
              <a:srgbClr val="ffff99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14"/>
            <p:cNvSpPr/>
            <p:nvPr/>
          </p:nvSpPr>
          <p:spPr>
            <a:xfrm>
              <a:off x="5472000" y="1643040"/>
              <a:ext cx="144720" cy="144360"/>
            </a:xfrm>
            <a:prstGeom prst="rect">
              <a:avLst/>
            </a:prstGeom>
            <a:solidFill>
              <a:srgbClr val="ff99cc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15"/>
            <p:cNvSpPr/>
            <p:nvPr/>
          </p:nvSpPr>
          <p:spPr>
            <a:xfrm>
              <a:off x="5585760" y="1365120"/>
              <a:ext cx="113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mpty vect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16"/>
            <p:cNvSpPr/>
            <p:nvPr/>
          </p:nvSpPr>
          <p:spPr>
            <a:xfrm>
              <a:off x="5586840" y="1568520"/>
              <a:ext cx="58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-Sce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Group 176"/>
            <p:cNvGrpSpPr/>
            <p:nvPr/>
          </p:nvGrpSpPr>
          <p:grpSpPr>
            <a:xfrm>
              <a:off x="5365800" y="1281240"/>
              <a:ext cx="2324160" cy="3190680"/>
              <a:chOff x="5365800" y="1281240"/>
              <a:chExt cx="2324160" cy="3190680"/>
            </a:xfrm>
          </p:grpSpPr>
          <p:sp>
            <p:nvSpPr>
              <p:cNvPr id="60" name="Rectangle 127"/>
              <p:cNvSpPr/>
              <p:nvPr/>
            </p:nvSpPr>
            <p:spPr>
              <a:xfrm>
                <a:off x="5365800" y="1281240"/>
                <a:ext cx="2324160" cy="319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Rectangle 128"/>
              <p:cNvSpPr/>
              <p:nvPr/>
            </p:nvSpPr>
            <p:spPr>
              <a:xfrm>
                <a:off x="5365800" y="1281240"/>
                <a:ext cx="2324160" cy="319068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129"/>
              <p:cNvSpPr/>
              <p:nvPr/>
            </p:nvSpPr>
            <p:spPr>
              <a:xfrm>
                <a:off x="5441760" y="2881080"/>
                <a:ext cx="314640" cy="1590480"/>
              </a:xfrm>
              <a:prstGeom prst="rect">
                <a:avLst/>
              </a:prstGeom>
              <a:solidFill>
                <a:srgbClr val="ffffcc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Rectangle 130"/>
              <p:cNvSpPr/>
              <p:nvPr/>
            </p:nvSpPr>
            <p:spPr>
              <a:xfrm>
                <a:off x="6213600" y="2881080"/>
                <a:ext cx="314280" cy="1590480"/>
              </a:xfrm>
              <a:prstGeom prst="rect">
                <a:avLst/>
              </a:prstGeom>
              <a:solidFill>
                <a:srgbClr val="ffffcc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131"/>
              <p:cNvSpPr/>
              <p:nvPr/>
            </p:nvSpPr>
            <p:spPr>
              <a:xfrm>
                <a:off x="6994440" y="2881080"/>
                <a:ext cx="314280" cy="1590480"/>
              </a:xfrm>
              <a:prstGeom prst="rect">
                <a:avLst/>
              </a:prstGeom>
              <a:solidFill>
                <a:srgbClr val="ffffcc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132"/>
              <p:cNvSpPr/>
              <p:nvPr/>
            </p:nvSpPr>
            <p:spPr>
              <a:xfrm>
                <a:off x="5756400" y="2981160"/>
                <a:ext cx="304560" cy="1490400"/>
              </a:xfrm>
              <a:prstGeom prst="rect">
                <a:avLst/>
              </a:prstGeom>
              <a:solidFill>
                <a:srgbClr val="ff99cc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ctangle 133"/>
              <p:cNvSpPr/>
              <p:nvPr/>
            </p:nvSpPr>
            <p:spPr>
              <a:xfrm>
                <a:off x="6527880" y="3000240"/>
                <a:ext cx="314280" cy="1471320"/>
              </a:xfrm>
              <a:prstGeom prst="rect">
                <a:avLst/>
              </a:prstGeom>
              <a:solidFill>
                <a:srgbClr val="ff99cc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134"/>
              <p:cNvSpPr/>
              <p:nvPr/>
            </p:nvSpPr>
            <p:spPr>
              <a:xfrm>
                <a:off x="7308720" y="2523960"/>
                <a:ext cx="304920" cy="1947600"/>
              </a:xfrm>
              <a:prstGeom prst="rect">
                <a:avLst/>
              </a:prstGeom>
              <a:solidFill>
                <a:srgbClr val="ff99cc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135"/>
              <p:cNvSpPr/>
              <p:nvPr/>
            </p:nvSpPr>
            <p:spPr>
              <a:xfrm flipV="1">
                <a:off x="5594400" y="2383920"/>
                <a:ext cx="0" cy="496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136"/>
              <p:cNvSpPr/>
              <p:nvPr/>
            </p:nvSpPr>
            <p:spPr>
              <a:xfrm>
                <a:off x="5565600" y="2384280"/>
                <a:ext cx="669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137"/>
              <p:cNvSpPr/>
              <p:nvPr/>
            </p:nvSpPr>
            <p:spPr>
              <a:xfrm flipV="1">
                <a:off x="6365880" y="2792160"/>
                <a:ext cx="0" cy="88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760" bIns="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138"/>
              <p:cNvSpPr/>
              <p:nvPr/>
            </p:nvSpPr>
            <p:spPr>
              <a:xfrm>
                <a:off x="6337080" y="2792160"/>
                <a:ext cx="669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139"/>
              <p:cNvSpPr/>
              <p:nvPr/>
            </p:nvSpPr>
            <p:spPr>
              <a:xfrm flipV="1">
                <a:off x="7146720" y="2682720"/>
                <a:ext cx="0" cy="1980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140"/>
              <p:cNvSpPr/>
              <p:nvPr/>
            </p:nvSpPr>
            <p:spPr>
              <a:xfrm>
                <a:off x="7118280" y="2682720"/>
                <a:ext cx="66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141"/>
              <p:cNvSpPr/>
              <p:nvPr/>
            </p:nvSpPr>
            <p:spPr>
              <a:xfrm>
                <a:off x="5594400" y="2881080"/>
                <a:ext cx="0" cy="4870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142"/>
              <p:cNvSpPr/>
              <p:nvPr/>
            </p:nvSpPr>
            <p:spPr>
              <a:xfrm>
                <a:off x="5565600" y="3368520"/>
                <a:ext cx="669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143"/>
              <p:cNvSpPr/>
              <p:nvPr/>
            </p:nvSpPr>
            <p:spPr>
              <a:xfrm>
                <a:off x="6365880" y="2881080"/>
                <a:ext cx="0" cy="79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144"/>
              <p:cNvSpPr/>
              <p:nvPr/>
            </p:nvSpPr>
            <p:spPr>
              <a:xfrm>
                <a:off x="6337080" y="2960640"/>
                <a:ext cx="669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145"/>
              <p:cNvSpPr/>
              <p:nvPr/>
            </p:nvSpPr>
            <p:spPr>
              <a:xfrm>
                <a:off x="7146720" y="2881080"/>
                <a:ext cx="0" cy="188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146"/>
              <p:cNvSpPr/>
              <p:nvPr/>
            </p:nvSpPr>
            <p:spPr>
              <a:xfrm>
                <a:off x="7118280" y="3070080"/>
                <a:ext cx="66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147"/>
              <p:cNvSpPr/>
              <p:nvPr/>
            </p:nvSpPr>
            <p:spPr>
              <a:xfrm flipV="1">
                <a:off x="5908680" y="2643120"/>
                <a:ext cx="0" cy="337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148"/>
              <p:cNvSpPr/>
              <p:nvPr/>
            </p:nvSpPr>
            <p:spPr>
              <a:xfrm>
                <a:off x="5879880" y="2643120"/>
                <a:ext cx="669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149"/>
              <p:cNvSpPr/>
              <p:nvPr/>
            </p:nvSpPr>
            <p:spPr>
              <a:xfrm flipV="1">
                <a:off x="6680160" y="2832120"/>
                <a:ext cx="0" cy="167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150"/>
              <p:cNvSpPr/>
              <p:nvPr/>
            </p:nvSpPr>
            <p:spPr>
              <a:xfrm>
                <a:off x="6651720" y="2832120"/>
                <a:ext cx="66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151"/>
              <p:cNvSpPr/>
              <p:nvPr/>
            </p:nvSpPr>
            <p:spPr>
              <a:xfrm flipV="1">
                <a:off x="7461360" y="2106000"/>
                <a:ext cx="0" cy="417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152"/>
              <p:cNvSpPr/>
              <p:nvPr/>
            </p:nvSpPr>
            <p:spPr>
              <a:xfrm>
                <a:off x="7432560" y="2106360"/>
                <a:ext cx="66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Line 153"/>
              <p:cNvSpPr/>
              <p:nvPr/>
            </p:nvSpPr>
            <p:spPr>
              <a:xfrm>
                <a:off x="5908680" y="2981160"/>
                <a:ext cx="0" cy="3265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154"/>
              <p:cNvSpPr/>
              <p:nvPr/>
            </p:nvSpPr>
            <p:spPr>
              <a:xfrm>
                <a:off x="5879880" y="3308040"/>
                <a:ext cx="669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155"/>
              <p:cNvSpPr/>
              <p:nvPr/>
            </p:nvSpPr>
            <p:spPr>
              <a:xfrm>
                <a:off x="6680160" y="3000240"/>
                <a:ext cx="0" cy="169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156"/>
              <p:cNvSpPr/>
              <p:nvPr/>
            </p:nvSpPr>
            <p:spPr>
              <a:xfrm>
                <a:off x="6651720" y="3170160"/>
                <a:ext cx="66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157"/>
              <p:cNvSpPr/>
              <p:nvPr/>
            </p:nvSpPr>
            <p:spPr>
              <a:xfrm>
                <a:off x="7461360" y="2523960"/>
                <a:ext cx="0" cy="426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158"/>
              <p:cNvSpPr/>
              <p:nvPr/>
            </p:nvSpPr>
            <p:spPr>
              <a:xfrm>
                <a:off x="7432560" y="2950920"/>
                <a:ext cx="66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161"/>
              <p:cNvSpPr/>
              <p:nvPr/>
            </p:nvSpPr>
            <p:spPr>
              <a:xfrm>
                <a:off x="5365800" y="3676680"/>
                <a:ext cx="381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162"/>
              <p:cNvSpPr/>
              <p:nvPr/>
            </p:nvSpPr>
            <p:spPr>
              <a:xfrm>
                <a:off x="5365800" y="2881080"/>
                <a:ext cx="381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163"/>
              <p:cNvSpPr/>
              <p:nvPr/>
            </p:nvSpPr>
            <p:spPr>
              <a:xfrm>
                <a:off x="5365800" y="2076480"/>
                <a:ext cx="381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167"/>
              <p:cNvSpPr/>
              <p:nvPr/>
            </p:nvSpPr>
            <p:spPr>
              <a:xfrm flipV="1">
                <a:off x="6137280" y="4441320"/>
                <a:ext cx="0" cy="29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168"/>
              <p:cNvSpPr/>
              <p:nvPr/>
            </p:nvSpPr>
            <p:spPr>
              <a:xfrm flipV="1">
                <a:off x="6918120" y="4441320"/>
                <a:ext cx="0" cy="29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7" name="Text Box 177"/>
            <p:cNvSpPr/>
            <p:nvPr/>
          </p:nvSpPr>
          <p:spPr>
            <a:xfrm>
              <a:off x="6060960" y="4460760"/>
              <a:ext cx="930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Arial"/>
                </a:rPr>
                <a:t>KD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Arial"/>
                </a:rPr>
                <a:t>Ku7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8" name="Group 184"/>
          <p:cNvGrpSpPr/>
          <p:nvPr/>
        </p:nvGrpSpPr>
        <p:grpSpPr>
          <a:xfrm>
            <a:off x="636840" y="457200"/>
            <a:ext cx="3720600" cy="4653000"/>
            <a:chOff x="636840" y="457200"/>
            <a:chExt cx="3720600" cy="4653000"/>
          </a:xfrm>
        </p:grpSpPr>
        <p:graphicFrame>
          <p:nvGraphicFramePr>
            <p:cNvPr id="99" name="Object 63"/>
            <p:cNvGraphicFramePr/>
            <p:nvPr/>
          </p:nvGraphicFramePr>
          <p:xfrm>
            <a:off x="1217520" y="2200320"/>
            <a:ext cx="1440000" cy="14396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100" name="Object 63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217520" y="2200320"/>
                      <a:ext cx="1440000" cy="1439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01" name="Object 64"/>
            <p:cNvGraphicFramePr/>
            <p:nvPr/>
          </p:nvGraphicFramePr>
          <p:xfrm>
            <a:off x="1217520" y="3670200"/>
            <a:ext cx="1440000" cy="144000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102" name="Object 64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217520" y="3670200"/>
                      <a:ext cx="144000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03" name="Object 65"/>
            <p:cNvGraphicFramePr/>
            <p:nvPr/>
          </p:nvGraphicFramePr>
          <p:xfrm>
            <a:off x="2687760" y="2200320"/>
            <a:ext cx="1439640" cy="143964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104" name="Object 65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2687760" y="2200320"/>
                      <a:ext cx="1439640" cy="1439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05" name="Object 66"/>
            <p:cNvGraphicFramePr/>
            <p:nvPr/>
          </p:nvGraphicFramePr>
          <p:xfrm>
            <a:off x="2687760" y="3670200"/>
            <a:ext cx="1439640" cy="144000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106" name="Object 66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2687760" y="3670200"/>
                      <a:ext cx="143964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07" name="Object 67"/>
            <p:cNvGraphicFramePr/>
            <p:nvPr/>
          </p:nvGraphicFramePr>
          <p:xfrm>
            <a:off x="1217520" y="730080"/>
            <a:ext cx="1440000" cy="144000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08" name="Object 67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1217520" y="730080"/>
                      <a:ext cx="144000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09" name="Object 68"/>
            <p:cNvGraphicFramePr/>
            <p:nvPr/>
          </p:nvGraphicFramePr>
          <p:xfrm>
            <a:off x="2687760" y="730080"/>
            <a:ext cx="1439640" cy="144000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110" name="Object 68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2687760" y="730080"/>
                      <a:ext cx="143964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11" name="Line 182"/>
            <p:cNvSpPr/>
            <p:nvPr/>
          </p:nvSpPr>
          <p:spPr>
            <a:xfrm>
              <a:off x="3908520" y="2076480"/>
              <a:ext cx="16020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69"/>
            <p:cNvSpPr/>
            <p:nvPr/>
          </p:nvSpPr>
          <p:spPr>
            <a:xfrm>
              <a:off x="1117440" y="457200"/>
              <a:ext cx="1538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U-UC9×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70"/>
            <p:cNvSpPr/>
            <p:nvPr/>
          </p:nvSpPr>
          <p:spPr>
            <a:xfrm>
              <a:off x="2690640" y="476280"/>
              <a:ext cx="1666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U-UC9×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Arial"/>
                </a:rPr>
                <a:t>KD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Arial"/>
                </a:rPr>
                <a:t>Lig4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71"/>
            <p:cNvSpPr/>
            <p:nvPr/>
          </p:nvSpPr>
          <p:spPr>
            <a:xfrm>
              <a:off x="1292400" y="2155680"/>
              <a:ext cx="1290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Arial"/>
                </a:rPr>
                <a:t>empty vecto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72"/>
            <p:cNvSpPr/>
            <p:nvPr/>
          </p:nvSpPr>
          <p:spPr>
            <a:xfrm>
              <a:off x="3079440" y="3605040"/>
              <a:ext cx="657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Arial"/>
                </a:rPr>
                <a:t>I-Sce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73"/>
            <p:cNvSpPr/>
            <p:nvPr/>
          </p:nvSpPr>
          <p:spPr>
            <a:xfrm>
              <a:off x="2762640" y="2155680"/>
              <a:ext cx="1290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Arial"/>
                </a:rPr>
                <a:t>empty vecto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74"/>
            <p:cNvSpPr/>
            <p:nvPr/>
          </p:nvSpPr>
          <p:spPr>
            <a:xfrm>
              <a:off x="1608120" y="3605040"/>
              <a:ext cx="657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Arial"/>
                </a:rPr>
                <a:t>I-Sce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179"/>
            <p:cNvSpPr/>
            <p:nvPr/>
          </p:nvSpPr>
          <p:spPr>
            <a:xfrm>
              <a:off x="636840" y="1298520"/>
              <a:ext cx="416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180"/>
            <p:cNvSpPr/>
            <p:nvPr/>
          </p:nvSpPr>
          <p:spPr>
            <a:xfrm>
              <a:off x="637200" y="2766960"/>
              <a:ext cx="545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U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181"/>
            <p:cNvSpPr/>
            <p:nvPr/>
          </p:nvSpPr>
          <p:spPr>
            <a:xfrm>
              <a:off x="637200" y="4238640"/>
              <a:ext cx="545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U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Text Box 186"/>
          <p:cNvSpPr/>
          <p:nvPr/>
        </p:nvSpPr>
        <p:spPr>
          <a:xfrm>
            <a:off x="7958160" y="189000"/>
            <a:ext cx="90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.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05T10:07:53Z</dcterms:created>
  <dc:creator>Ayako</dc:creator>
  <dc:description/>
  <dc:language>en-US</dc:language>
  <cp:lastModifiedBy>Ayako</cp:lastModifiedBy>
  <dcterms:modified xsi:type="dcterms:W3CDTF">2012-08-24T04:26:09Z</dcterms:modified>
  <cp:revision>17</cp:revision>
  <dc:subject/>
  <dc:title>スライド 1</dc:title>
</cp:coreProperties>
</file>